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4" r:id="rId2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24"/>
  </p:normalViewPr>
  <p:slideViewPr>
    <p:cSldViewPr snapToGrid="0" snapToObjects="1">
      <p:cViewPr varScale="1">
        <p:scale>
          <a:sx n="65" d="100"/>
          <a:sy n="65" d="100"/>
        </p:scale>
        <p:origin x="283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9E7DE-8482-084A-81B3-48BFF68B3FD5}" type="datetimeFigureOut">
              <a:rPr lang="en-US" smtClean="0"/>
              <a:t>2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18339-41EE-794E-82E5-B2C21B9A77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2942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9E7DE-8482-084A-81B3-48BFF68B3FD5}" type="datetimeFigureOut">
              <a:rPr lang="en-US" smtClean="0"/>
              <a:t>2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18339-41EE-794E-82E5-B2C21B9A77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349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9E7DE-8482-084A-81B3-48BFF68B3FD5}" type="datetimeFigureOut">
              <a:rPr lang="en-US" smtClean="0"/>
              <a:t>2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18339-41EE-794E-82E5-B2C21B9A77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92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9E7DE-8482-084A-81B3-48BFF68B3FD5}" type="datetimeFigureOut">
              <a:rPr lang="en-US" smtClean="0"/>
              <a:t>2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18339-41EE-794E-82E5-B2C21B9A77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7857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9E7DE-8482-084A-81B3-48BFF68B3FD5}" type="datetimeFigureOut">
              <a:rPr lang="en-US" smtClean="0"/>
              <a:t>2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18339-41EE-794E-82E5-B2C21B9A77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895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9E7DE-8482-084A-81B3-48BFF68B3FD5}" type="datetimeFigureOut">
              <a:rPr lang="en-US" smtClean="0"/>
              <a:t>2/1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18339-41EE-794E-82E5-B2C21B9A77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65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9E7DE-8482-084A-81B3-48BFF68B3FD5}" type="datetimeFigureOut">
              <a:rPr lang="en-US" smtClean="0"/>
              <a:t>2/13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18339-41EE-794E-82E5-B2C21B9A77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999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9E7DE-8482-084A-81B3-48BFF68B3FD5}" type="datetimeFigureOut">
              <a:rPr lang="en-US" smtClean="0"/>
              <a:t>2/13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18339-41EE-794E-82E5-B2C21B9A77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0386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9E7DE-8482-084A-81B3-48BFF68B3FD5}" type="datetimeFigureOut">
              <a:rPr lang="en-US" smtClean="0"/>
              <a:t>2/13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18339-41EE-794E-82E5-B2C21B9A77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434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9E7DE-8482-084A-81B3-48BFF68B3FD5}" type="datetimeFigureOut">
              <a:rPr lang="en-US" smtClean="0"/>
              <a:t>2/1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18339-41EE-794E-82E5-B2C21B9A77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958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9E7DE-8482-084A-81B3-48BFF68B3FD5}" type="datetimeFigureOut">
              <a:rPr lang="en-US" smtClean="0"/>
              <a:t>2/1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18339-41EE-794E-82E5-B2C21B9A77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519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E9E7DE-8482-084A-81B3-48BFF68B3FD5}" type="datetimeFigureOut">
              <a:rPr lang="en-US" smtClean="0"/>
              <a:t>2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A18339-41EE-794E-82E5-B2C21B9A77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437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2269C5FD-4F8D-F04C-9674-37EAE8FFD847}"/>
              </a:ext>
            </a:extLst>
          </p:cNvPr>
          <p:cNvGrpSpPr/>
          <p:nvPr/>
        </p:nvGrpSpPr>
        <p:grpSpPr>
          <a:xfrm>
            <a:off x="876968" y="710330"/>
            <a:ext cx="5096041" cy="7576420"/>
            <a:chOff x="876967" y="581200"/>
            <a:chExt cx="5096041" cy="757642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D8CC8C3-1C8A-6849-93B5-65A20208914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31188" y="581200"/>
              <a:ext cx="2387600" cy="2476500"/>
            </a:xfrm>
            <a:prstGeom prst="rect">
              <a:avLst/>
            </a:prstGeom>
          </p:spPr>
        </p:pic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E4536794-383A-C94D-A2F6-A3F462F1EA3C}"/>
                </a:ext>
              </a:extLst>
            </p:cNvPr>
            <p:cNvGrpSpPr/>
            <p:nvPr/>
          </p:nvGrpSpPr>
          <p:grpSpPr>
            <a:xfrm>
              <a:off x="876967" y="3039116"/>
              <a:ext cx="5096041" cy="5118504"/>
              <a:chOff x="1041400" y="3204620"/>
              <a:chExt cx="5096041" cy="5118504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1FE9FB6B-9DA9-A540-B148-39C8A6533E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041400" y="3204620"/>
                <a:ext cx="2387600" cy="2476500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0F5AD83A-0722-7045-BA53-C8578988B54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749841" y="3204620"/>
                <a:ext cx="2387600" cy="2476500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C4989B92-3CFD-A54A-8EB4-297F1EE471F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041400" y="5846624"/>
                <a:ext cx="2387600" cy="2476500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7B3555C7-3F1C-0A42-AC53-474B407303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749841" y="5846624"/>
                <a:ext cx="2387600" cy="2476500"/>
              </a:xfrm>
              <a:prstGeom prst="rect">
                <a:avLst/>
              </a:prstGeom>
            </p:spPr>
          </p:pic>
        </p:grp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B56C31FB-ACE0-0D45-8688-4706F1F34402}"/>
              </a:ext>
            </a:extLst>
          </p:cNvPr>
          <p:cNvSpPr txBox="1"/>
          <p:nvPr/>
        </p:nvSpPr>
        <p:spPr>
          <a:xfrm>
            <a:off x="178176" y="8508611"/>
            <a:ext cx="650164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Quantification of Figure 2A - CCCP treatment does not reduce markers of mitochondrial protein content in skeletal muscle cells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arkers of mitochondrial content are unaltered following CCCP treatment for up to 24 h. C2C12 myotubes were treated with DMSO (0.1%, 24 h) as a vehicle control (CTRL) or 10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 CCCP for up to 24 h. Total lysates were analyzed by SDS‐PAGE and western blotting. Representative images of n = 3 independent experiments are shown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CB189D8-BBAE-9249-AB25-C781D9FE843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6607" t="38882" b="32006"/>
          <a:stretch/>
        </p:blipFill>
        <p:spPr>
          <a:xfrm>
            <a:off x="3917462" y="654767"/>
            <a:ext cx="2055546" cy="720971"/>
          </a:xfrm>
          <a:prstGeom prst="rect">
            <a:avLst/>
          </a:prstGeom>
        </p:spPr>
      </p:pic>
      <p:sp>
        <p:nvSpPr>
          <p:cNvPr id="16" name="TextBox 62">
            <a:extLst>
              <a:ext uri="{FF2B5EF4-FFF2-40B4-BE49-F238E27FC236}">
                <a16:creationId xmlns:a16="http://schemas.microsoft.com/office/drawing/2014/main" id="{C2A6A361-1E95-1849-8ECF-7A6E1654F1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210" y="163300"/>
            <a:ext cx="3080085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1pPr>
            <a:lvl2pPr marL="1350963" indent="-274638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2pPr>
            <a:lvl3pPr marL="2701925" indent="-550863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3pPr>
            <a:lvl4pPr marL="4052888" indent="-827088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4pPr>
            <a:lvl5pPr marL="5407025" indent="-1108075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741348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1</TotalTime>
  <Words>95</Words>
  <Application>Microsoft Macintosh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5</cp:revision>
  <dcterms:created xsi:type="dcterms:W3CDTF">2020-02-09T21:46:39Z</dcterms:created>
  <dcterms:modified xsi:type="dcterms:W3CDTF">2020-02-13T20:48:11Z</dcterms:modified>
</cp:coreProperties>
</file>